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47" autoAdjust="0"/>
    <p:restoredTop sz="93736" autoAdjust="0"/>
  </p:normalViewPr>
  <p:slideViewPr>
    <p:cSldViewPr>
      <p:cViewPr>
        <p:scale>
          <a:sx n="150" d="100"/>
          <a:sy n="150" d="100"/>
        </p:scale>
        <p:origin x="504" y="-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tiff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2FF647A-CE10-BD3C-E27E-8412730DBA2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52090" y="416496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BC26034-8833-B589-C9D2-DD0438DB75C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3934455"/>
            <a:ext cx="2340864" cy="15605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6DAAAE9-E058-9C67-812A-730C3A0ECA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464" y="2043179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A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66123" y="2007863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427812" y="434753"/>
            <a:ext cx="6110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2954710" y="2921723"/>
            <a:ext cx="762322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A59028FF-99AB-97A8-0B1F-340827D67C05}"/>
              </a:ext>
            </a:extLst>
          </p:cNvPr>
          <p:cNvSpPr txBox="1"/>
          <p:nvPr/>
        </p:nvSpPr>
        <p:spPr>
          <a:xfrm>
            <a:off x="-85530" y="3951719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68301DD-CF29-29F0-C712-D506604057BE}"/>
              </a:ext>
            </a:extLst>
          </p:cNvPr>
          <p:cNvSpPr/>
          <p:nvPr/>
        </p:nvSpPr>
        <p:spPr>
          <a:xfrm>
            <a:off x="980728" y="4791657"/>
            <a:ext cx="576064" cy="17669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B9FECC3-9199-661C-0B36-2024F74B792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52090" y="2029115"/>
            <a:ext cx="2340864" cy="1560576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7F0D9E23-D2D1-CB07-55AB-6DEA7E8D4025}"/>
              </a:ext>
            </a:extLst>
          </p:cNvPr>
          <p:cNvSpPr/>
          <p:nvPr/>
        </p:nvSpPr>
        <p:spPr>
          <a:xfrm>
            <a:off x="3501008" y="1352601"/>
            <a:ext cx="576064" cy="14401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62E48EC7-0362-8D40-F1F8-BB68F8C332A7}"/>
              </a:ext>
            </a:extLst>
          </p:cNvPr>
          <p:cNvSpPr/>
          <p:nvPr/>
        </p:nvSpPr>
        <p:spPr>
          <a:xfrm>
            <a:off x="958445" y="2796506"/>
            <a:ext cx="576064" cy="17669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724C716A-BA2B-EB7A-137D-4632B4072943}"/>
              </a:ext>
            </a:extLst>
          </p:cNvPr>
          <p:cNvSpPr/>
          <p:nvPr/>
        </p:nvSpPr>
        <p:spPr>
          <a:xfrm>
            <a:off x="3377081" y="2833149"/>
            <a:ext cx="576064" cy="17669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C85BD35E-4AD9-DA2F-F765-AACD6FEEDA8E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75" y="447287"/>
            <a:ext cx="2340864" cy="1560576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06837A16-BDBA-64A4-9927-E866CC882C38}"/>
              </a:ext>
            </a:extLst>
          </p:cNvPr>
          <p:cNvSpPr/>
          <p:nvPr/>
        </p:nvSpPr>
        <p:spPr>
          <a:xfrm>
            <a:off x="899375" y="1271903"/>
            <a:ext cx="576064" cy="17669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TextBox 12">
            <a:extLst>
              <a:ext uri="{FF2B5EF4-FFF2-40B4-BE49-F238E27FC236}">
                <a16:creationId xmlns:a16="http://schemas.microsoft.com/office/drawing/2014/main" id="{4360416A-DF93-BBD4-CED2-5B97A2A308FE}"/>
              </a:ext>
            </a:extLst>
          </p:cNvPr>
          <p:cNvSpPr txBox="1"/>
          <p:nvPr/>
        </p:nvSpPr>
        <p:spPr>
          <a:xfrm>
            <a:off x="-46136" y="447287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</a:t>
            </a:r>
            <a:endParaRPr lang="zh-CN" altLang="en-US" sz="1400"/>
          </a:p>
        </p:txBody>
      </p:sp>
      <p:sp>
        <p:nvSpPr>
          <p:cNvPr id="8" name="TextBox 8">
            <a:extLst>
              <a:ext uri="{FF2B5EF4-FFF2-40B4-BE49-F238E27FC236}">
                <a16:creationId xmlns:a16="http://schemas.microsoft.com/office/drawing/2014/main" id="{8F83713A-9434-5C76-C2E6-ADC2236C1C0C}"/>
              </a:ext>
            </a:extLst>
          </p:cNvPr>
          <p:cNvSpPr txBox="1"/>
          <p:nvPr/>
        </p:nvSpPr>
        <p:spPr>
          <a:xfrm>
            <a:off x="2427812" y="2014515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766FFA59-EF7C-22DB-AA49-D6D62A895BC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" y="210450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CC68BBA-DD77-6BA6-A134-EC0F41F92A1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1940690"/>
            <a:ext cx="2341397" cy="156093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85C8CD5-968F-441D-ADFC-7AA3C0A7178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9898" y="210094"/>
            <a:ext cx="2341397" cy="156093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28681C1-FC69-E551-4CB4-57D7E953798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6554" y="1940690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C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1940691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2830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272480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3309468" y="2810496"/>
            <a:ext cx="769383" cy="14401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1940690"/>
            <a:ext cx="7120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  <a:p>
            <a:endParaRPr lang="en-US" altLang="zh-CN" sz="1400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55D167-B0FC-D7ED-0A8B-0E5428FE4E83}"/>
              </a:ext>
            </a:extLst>
          </p:cNvPr>
          <p:cNvSpPr/>
          <p:nvPr/>
        </p:nvSpPr>
        <p:spPr>
          <a:xfrm>
            <a:off x="851818" y="2822182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CAA9CC4-32C6-9289-F215-590F56772B3A}"/>
              </a:ext>
            </a:extLst>
          </p:cNvPr>
          <p:cNvSpPr/>
          <p:nvPr/>
        </p:nvSpPr>
        <p:spPr>
          <a:xfrm>
            <a:off x="3212829" y="1010550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851818" y="990560"/>
            <a:ext cx="704974" cy="16036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0650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31DB3B03-3F0E-EF90-DF56-4C97C34494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6" y="2008032"/>
            <a:ext cx="2340864" cy="15605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F9D5E1F-CB7D-D1A7-E178-F5463405B23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6396" y="303908"/>
            <a:ext cx="2340864" cy="15605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D5EDE10-43A9-A45D-D077-98ED3DE029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98" y="281807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88C7F68-FD29-0FA6-A7D8-3A14B5DD807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812" y="2008032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E</a:t>
            </a:r>
            <a:endParaRPr lang="zh-CN" altLang="en-US" sz="14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1B1A1C-DA04-48A5-CD9B-EAC47970A64F}"/>
              </a:ext>
            </a:extLst>
          </p:cNvPr>
          <p:cNvSpPr txBox="1"/>
          <p:nvPr/>
        </p:nvSpPr>
        <p:spPr>
          <a:xfrm>
            <a:off x="-69378" y="2031249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8384FFB4-8116-AB4E-C2A9-C39065DD020B}"/>
              </a:ext>
            </a:extLst>
          </p:cNvPr>
          <p:cNvSpPr txBox="1"/>
          <p:nvPr/>
        </p:nvSpPr>
        <p:spPr>
          <a:xfrm>
            <a:off x="-27384" y="283078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7E606859-7490-224F-E76D-A6962C87A285}"/>
              </a:ext>
            </a:extLst>
          </p:cNvPr>
          <p:cNvSpPr txBox="1"/>
          <p:nvPr/>
        </p:nvSpPr>
        <p:spPr>
          <a:xfrm>
            <a:off x="2396554" y="272480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DA6762DC-6150-076B-6153-13905C193FD9}"/>
              </a:ext>
            </a:extLst>
          </p:cNvPr>
          <p:cNvSpPr txBox="1"/>
          <p:nvPr/>
        </p:nvSpPr>
        <p:spPr>
          <a:xfrm>
            <a:off x="2427812" y="203524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3367910-DD2E-4B5A-989A-2E944C238818}"/>
              </a:ext>
            </a:extLst>
          </p:cNvPr>
          <p:cNvSpPr/>
          <p:nvPr/>
        </p:nvSpPr>
        <p:spPr>
          <a:xfrm>
            <a:off x="836712" y="2834519"/>
            <a:ext cx="1024964" cy="17561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3D0635E0-D351-4F4B-887F-00E6DB655FF8}"/>
              </a:ext>
            </a:extLst>
          </p:cNvPr>
          <p:cNvSpPr/>
          <p:nvPr/>
        </p:nvSpPr>
        <p:spPr>
          <a:xfrm>
            <a:off x="3140968" y="2788320"/>
            <a:ext cx="1024964" cy="25030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C259989D-C3E4-BE21-DC4C-3861818048CE}"/>
              </a:ext>
            </a:extLst>
          </p:cNvPr>
          <p:cNvSpPr/>
          <p:nvPr/>
        </p:nvSpPr>
        <p:spPr>
          <a:xfrm>
            <a:off x="712842" y="1210781"/>
            <a:ext cx="1024964" cy="23353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D5AAB092-9C67-63BD-3061-C00A1AD24EB2}"/>
              </a:ext>
            </a:extLst>
          </p:cNvPr>
          <p:cNvSpPr/>
          <p:nvPr/>
        </p:nvSpPr>
        <p:spPr>
          <a:xfrm>
            <a:off x="3212976" y="1062095"/>
            <a:ext cx="1024964" cy="17561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9810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1F5E3CD-B7F9-053B-6A5E-13839105AA5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6638" y="2031249"/>
            <a:ext cx="2340864" cy="156057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77AA295-FD22-80EB-BA98-EC17BBFA43D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3609" y="2031249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1EA5636-5C32-AE6A-B821-3C2985738CB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03692" y="311514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9D6B5DC-F868-68E5-0741-16862DEFC77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312666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G</a:t>
            </a:r>
            <a:endParaRPr lang="zh-CN" altLang="en-US" sz="140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1B1A1C-DA04-48A5-CD9B-EAC47970A64F}"/>
              </a:ext>
            </a:extLst>
          </p:cNvPr>
          <p:cNvSpPr txBox="1"/>
          <p:nvPr/>
        </p:nvSpPr>
        <p:spPr>
          <a:xfrm>
            <a:off x="-69378" y="2031249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8384FFB4-8116-AB4E-C2A9-C39065DD020B}"/>
              </a:ext>
            </a:extLst>
          </p:cNvPr>
          <p:cNvSpPr txBox="1"/>
          <p:nvPr/>
        </p:nvSpPr>
        <p:spPr>
          <a:xfrm>
            <a:off x="-27384" y="283078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</a:t>
            </a:r>
            <a:endParaRPr lang="zh-CN" altLang="en-US" sz="1400"/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7E606859-7490-224F-E76D-A6962C87A285}"/>
              </a:ext>
            </a:extLst>
          </p:cNvPr>
          <p:cNvSpPr txBox="1"/>
          <p:nvPr/>
        </p:nvSpPr>
        <p:spPr>
          <a:xfrm>
            <a:off x="2396554" y="272480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DA6762DC-6150-076B-6153-13905C193FD9}"/>
              </a:ext>
            </a:extLst>
          </p:cNvPr>
          <p:cNvSpPr txBox="1"/>
          <p:nvPr/>
        </p:nvSpPr>
        <p:spPr>
          <a:xfrm>
            <a:off x="2427812" y="203524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3367910-DD2E-4B5A-989A-2E944C238818}"/>
              </a:ext>
            </a:extLst>
          </p:cNvPr>
          <p:cNvSpPr/>
          <p:nvPr/>
        </p:nvSpPr>
        <p:spPr>
          <a:xfrm>
            <a:off x="1196752" y="2792761"/>
            <a:ext cx="576064" cy="2173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3D0635E0-D351-4F4B-887F-00E6DB655FF8}"/>
              </a:ext>
            </a:extLst>
          </p:cNvPr>
          <p:cNvSpPr/>
          <p:nvPr/>
        </p:nvSpPr>
        <p:spPr>
          <a:xfrm>
            <a:off x="3708606" y="2792761"/>
            <a:ext cx="584490" cy="21737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C259989D-C3E4-BE21-DC4C-3861818048CE}"/>
              </a:ext>
            </a:extLst>
          </p:cNvPr>
          <p:cNvSpPr/>
          <p:nvPr/>
        </p:nvSpPr>
        <p:spPr>
          <a:xfrm>
            <a:off x="1266797" y="1164999"/>
            <a:ext cx="567660" cy="18760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D5AAB092-9C67-63BD-3061-C00A1AD24EB2}"/>
              </a:ext>
            </a:extLst>
          </p:cNvPr>
          <p:cNvSpPr/>
          <p:nvPr/>
        </p:nvSpPr>
        <p:spPr>
          <a:xfrm>
            <a:off x="3573016" y="1109833"/>
            <a:ext cx="648072" cy="17076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766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61</TotalTime>
  <Words>31</Words>
  <Application>Microsoft Office PowerPoint</Application>
  <PresentationFormat>A4 纸张(210x297 毫米)</PresentationFormat>
  <Paragraphs>2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文龙 任</cp:lastModifiedBy>
  <cp:revision>252</cp:revision>
  <dcterms:created xsi:type="dcterms:W3CDTF">2023-02-16T12:33:32Z</dcterms:created>
  <dcterms:modified xsi:type="dcterms:W3CDTF">2024-10-07T17:45:32Z</dcterms:modified>
</cp:coreProperties>
</file>